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9" r:id="rId2"/>
    <p:sldId id="258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27"/>
    <p:restoredTop sz="94603"/>
  </p:normalViewPr>
  <p:slideViewPr>
    <p:cSldViewPr snapToGrid="0" snapToObjects="1">
      <p:cViewPr varScale="1">
        <p:scale>
          <a:sx n="116" d="100"/>
          <a:sy n="116" d="100"/>
        </p:scale>
        <p:origin x="216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86D0CB-DAA0-9447-9AAF-32C53A9AFED5}" type="datetimeFigureOut">
              <a:rPr lang="en-US" smtClean="0"/>
              <a:t>1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C7644F-E5D4-E449-B649-0DD630161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084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dirty="0"/>
              <a:t>Spectrum, Peak : sample specific</a:t>
            </a:r>
          </a:p>
          <a:p>
            <a:r>
              <a:rPr lang="en-US" sz="1200" dirty="0" err="1"/>
              <a:t>Featrure</a:t>
            </a:r>
            <a:r>
              <a:rPr lang="en-US" sz="1200" dirty="0"/>
              <a:t>, </a:t>
            </a:r>
            <a:r>
              <a:rPr lang="en-US" sz="1200" dirty="0" err="1"/>
              <a:t>empCpd</a:t>
            </a:r>
            <a:r>
              <a:rPr lang="en-US" sz="1200" dirty="0"/>
              <a:t> : experiment specific</a:t>
            </a:r>
          </a:p>
          <a:p>
            <a:r>
              <a:rPr lang="en-US" sz="1200" dirty="0" err="1"/>
              <a:t>empCpd</a:t>
            </a:r>
            <a:r>
              <a:rPr lang="en-US" sz="1200" dirty="0"/>
              <a:t> = Empirical Compound</a:t>
            </a:r>
          </a:p>
          <a:p>
            <a:r>
              <a:rPr lang="en-US" sz="1200"/>
              <a:t>N:N = many to many mapping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C7644F-E5D4-E449-B649-0DD63016150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604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59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044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02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75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8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25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47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584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717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78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488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7EFC9-DECF-5B45-BE5A-207EC87BD6EF}" type="datetimeFigureOut">
              <a:rPr lang="en-US" smtClean="0"/>
              <a:t>1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DBBE4-F4DB-5C4B-8080-C195CACDAB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264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02C13C3-0A9A-9354-2DE6-8BB0B40FDA40}"/>
              </a:ext>
            </a:extLst>
          </p:cNvPr>
          <p:cNvGrpSpPr/>
          <p:nvPr/>
        </p:nvGrpSpPr>
        <p:grpSpPr>
          <a:xfrm>
            <a:off x="2197156" y="1404670"/>
            <a:ext cx="6542841" cy="4048659"/>
            <a:chOff x="434457" y="376576"/>
            <a:chExt cx="6542841" cy="4048659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8FCB24E-63A2-C93A-F053-DB24A870665B}"/>
                </a:ext>
              </a:extLst>
            </p:cNvPr>
            <p:cNvSpPr txBox="1"/>
            <p:nvPr/>
          </p:nvSpPr>
          <p:spPr>
            <a:xfrm>
              <a:off x="3541476" y="3503717"/>
              <a:ext cx="848502" cy="270843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100" dirty="0"/>
                <a:t>Annotation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530D6E5-C437-FAA2-49BD-1156637A306F}"/>
                </a:ext>
              </a:extLst>
            </p:cNvPr>
            <p:cNvSpPr txBox="1"/>
            <p:nvPr/>
          </p:nvSpPr>
          <p:spPr>
            <a:xfrm>
              <a:off x="4422056" y="770206"/>
              <a:ext cx="1252422" cy="270843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 algn="ctr"/>
              <a:r>
                <a:rPr lang="en-US" sz="1100" dirty="0"/>
                <a:t>Metabolic Model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A884B3E-E136-12A5-EB5A-8559632614E3}"/>
                </a:ext>
              </a:extLst>
            </p:cNvPr>
            <p:cNvSpPr txBox="1"/>
            <p:nvPr/>
          </p:nvSpPr>
          <p:spPr>
            <a:xfrm>
              <a:off x="1616135" y="3161945"/>
              <a:ext cx="1084784" cy="270843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Pre-annotation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E378AFE-C24E-414A-038A-F9837623B91D}"/>
                </a:ext>
              </a:extLst>
            </p:cNvPr>
            <p:cNvSpPr txBox="1"/>
            <p:nvPr/>
          </p:nvSpPr>
          <p:spPr>
            <a:xfrm>
              <a:off x="2158527" y="3558578"/>
              <a:ext cx="1005840" cy="440121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Empirical</a:t>
              </a:r>
              <a:br>
                <a:rPr lang="en-US" sz="1100" dirty="0"/>
              </a:br>
              <a:r>
                <a:rPr lang="en-US" sz="1100" dirty="0"/>
                <a:t>Compoun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3D0001F-8990-DE84-B6B6-6D3833B971B2}"/>
                </a:ext>
              </a:extLst>
            </p:cNvPr>
            <p:cNvSpPr txBox="1"/>
            <p:nvPr/>
          </p:nvSpPr>
          <p:spPr>
            <a:xfrm>
              <a:off x="2158527" y="2026943"/>
              <a:ext cx="1005840" cy="270843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1100" dirty="0"/>
                <a:t>Elution Peak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3AFA4FE-4E8C-CA15-612D-F66525FF49CB}"/>
                </a:ext>
              </a:extLst>
            </p:cNvPr>
            <p:cNvSpPr txBox="1"/>
            <p:nvPr/>
          </p:nvSpPr>
          <p:spPr>
            <a:xfrm>
              <a:off x="2158527" y="2813011"/>
              <a:ext cx="1005840" cy="270843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Featur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3E98601-2D9D-354A-FF9D-A28D06955C78}"/>
                </a:ext>
              </a:extLst>
            </p:cNvPr>
            <p:cNvSpPr txBox="1"/>
            <p:nvPr/>
          </p:nvSpPr>
          <p:spPr>
            <a:xfrm>
              <a:off x="2158527" y="1253568"/>
              <a:ext cx="1005840" cy="270843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Mass track (EIC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50F00D6-B351-1FF1-D218-F7C27AEE6C10}"/>
                </a:ext>
              </a:extLst>
            </p:cNvPr>
            <p:cNvSpPr txBox="1"/>
            <p:nvPr/>
          </p:nvSpPr>
          <p:spPr>
            <a:xfrm>
              <a:off x="962304" y="770206"/>
              <a:ext cx="1399780" cy="288730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Separation parameter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F18400E-4361-658F-3463-7F8679E4BF82}"/>
                </a:ext>
              </a:extLst>
            </p:cNvPr>
            <p:cNvSpPr txBox="1"/>
            <p:nvPr/>
          </p:nvSpPr>
          <p:spPr>
            <a:xfrm>
              <a:off x="434457" y="376576"/>
              <a:ext cx="1005840" cy="270843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Spectrum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C1B063E-0ADB-FE57-ACEB-A4C5BA8BA2DB}"/>
                </a:ext>
              </a:extLst>
            </p:cNvPr>
            <p:cNvSpPr txBox="1"/>
            <p:nvPr/>
          </p:nvSpPr>
          <p:spPr>
            <a:xfrm>
              <a:off x="434457" y="1253568"/>
              <a:ext cx="1005840" cy="270843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Array of Spectr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DCBAD96-EBB6-ADF6-45D8-77156AEF3427}"/>
                </a:ext>
              </a:extLst>
            </p:cNvPr>
            <p:cNvSpPr txBox="1"/>
            <p:nvPr/>
          </p:nvSpPr>
          <p:spPr>
            <a:xfrm>
              <a:off x="1603111" y="1640543"/>
              <a:ext cx="1058336" cy="270843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Peak detectio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B84E2A3-8B1D-AB25-5674-7BC68C6DA2D4}"/>
                </a:ext>
              </a:extLst>
            </p:cNvPr>
            <p:cNvSpPr txBox="1"/>
            <p:nvPr/>
          </p:nvSpPr>
          <p:spPr>
            <a:xfrm>
              <a:off x="6197565" y="1942304"/>
              <a:ext cx="779733" cy="44012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/>
                <a:t>Metabolic</a:t>
              </a:r>
              <a:br>
                <a:rPr lang="en-US" sz="1100"/>
              </a:br>
              <a:r>
                <a:rPr lang="en-US" sz="1100"/>
                <a:t>Network</a:t>
              </a:r>
              <a:endParaRPr lang="en-US" sz="11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9543F00-4F78-59AA-9FBD-73A17C43EEDC}"/>
                </a:ext>
              </a:extLst>
            </p:cNvPr>
            <p:cNvSpPr txBox="1"/>
            <p:nvPr/>
          </p:nvSpPr>
          <p:spPr>
            <a:xfrm>
              <a:off x="4987745" y="1253568"/>
              <a:ext cx="804672" cy="27084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Pathway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26A2369-AA92-02D0-B71C-E1B3140161A3}"/>
                </a:ext>
              </a:extLst>
            </p:cNvPr>
            <p:cNvSpPr txBox="1"/>
            <p:nvPr/>
          </p:nvSpPr>
          <p:spPr>
            <a:xfrm>
              <a:off x="4987745" y="2026943"/>
              <a:ext cx="804672" cy="27084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/>
                <a:t>Reaction</a:t>
              </a:r>
              <a:endParaRPr lang="en-US" sz="11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A3D1B8F-3AE2-8D72-571E-CFE159EDA0D2}"/>
                </a:ext>
              </a:extLst>
            </p:cNvPr>
            <p:cNvSpPr txBox="1"/>
            <p:nvPr/>
          </p:nvSpPr>
          <p:spPr>
            <a:xfrm>
              <a:off x="3795526" y="2026943"/>
              <a:ext cx="804672" cy="27084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Enzyme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29096EA-CD35-3A6B-08E6-7CECF0181725}"/>
                </a:ext>
              </a:extLst>
            </p:cNvPr>
            <p:cNvSpPr txBox="1"/>
            <p:nvPr/>
          </p:nvSpPr>
          <p:spPr>
            <a:xfrm>
              <a:off x="3795526" y="1253568"/>
              <a:ext cx="804672" cy="27084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Gene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529FADF-7268-35D3-C5F8-0D1E6EA3C592}"/>
                </a:ext>
              </a:extLst>
            </p:cNvPr>
            <p:cNvSpPr txBox="1"/>
            <p:nvPr/>
          </p:nvSpPr>
          <p:spPr>
            <a:xfrm>
              <a:off x="4887161" y="2733410"/>
              <a:ext cx="1005840" cy="438912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rtlCol="0">
              <a:noAutofit/>
            </a:bodyPr>
            <a:lstStyle/>
            <a:p>
              <a:pPr algn="ctr"/>
              <a:r>
                <a:rPr lang="en-US" sz="1100" dirty="0"/>
                <a:t>Compound</a:t>
              </a:r>
            </a:p>
            <a:p>
              <a:pPr algn="ctr"/>
              <a:r>
                <a:rPr lang="en-US" sz="1100" dirty="0"/>
                <a:t>(Metabolite)</a:t>
              </a:r>
            </a:p>
          </p:txBody>
        </p:sp>
        <p:cxnSp>
          <p:nvCxnSpPr>
            <p:cNvPr id="20" name="Elbow Connector 19">
              <a:extLst>
                <a:ext uri="{FF2B5EF4-FFF2-40B4-BE49-F238E27FC236}">
                  <a16:creationId xmlns:a16="http://schemas.microsoft.com/office/drawing/2014/main" id="{090B8867-F728-4BA5-D3AF-7E6A4E14CFF3}"/>
                </a:ext>
              </a:extLst>
            </p:cNvPr>
            <p:cNvCxnSpPr>
              <a:stCxn id="12" idx="2"/>
              <a:endCxn id="8" idx="1"/>
            </p:cNvCxnSpPr>
            <p:nvPr/>
          </p:nvCxnSpPr>
          <p:spPr>
            <a:xfrm rot="16200000" flipH="1">
              <a:off x="835941" y="1625847"/>
              <a:ext cx="1424022" cy="1221150"/>
            </a:xfrm>
            <a:prstGeom prst="bentConnector2">
              <a:avLst/>
            </a:prstGeom>
            <a:ln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3B5BD2A7-5766-510D-0EEE-15948FB28549}"/>
                </a:ext>
              </a:extLst>
            </p:cNvPr>
            <p:cNvCxnSpPr>
              <a:cxnSpLocks/>
              <a:stCxn id="8" idx="3"/>
              <a:endCxn id="19" idx="1"/>
            </p:cNvCxnSpPr>
            <p:nvPr/>
          </p:nvCxnSpPr>
          <p:spPr>
            <a:xfrm>
              <a:off x="3164367" y="2948433"/>
              <a:ext cx="1722794" cy="4433"/>
            </a:xfrm>
            <a:prstGeom prst="straightConnector1">
              <a:avLst/>
            </a:prstGeom>
            <a:ln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5065F5F1-DC40-50D5-D64F-4477A776CB50}"/>
                </a:ext>
              </a:extLst>
            </p:cNvPr>
            <p:cNvCxnSpPr>
              <a:stCxn id="11" idx="2"/>
              <a:endCxn id="12" idx="0"/>
            </p:cNvCxnSpPr>
            <p:nvPr/>
          </p:nvCxnSpPr>
          <p:spPr>
            <a:xfrm>
              <a:off x="937377" y="647419"/>
              <a:ext cx="0" cy="60614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A98CFF50-0CC9-A788-2CB0-4E3AE00B1C95}"/>
                </a:ext>
              </a:extLst>
            </p:cNvPr>
            <p:cNvCxnSpPr>
              <a:stCxn id="12" idx="3"/>
              <a:endCxn id="9" idx="1"/>
            </p:cNvCxnSpPr>
            <p:nvPr/>
          </p:nvCxnSpPr>
          <p:spPr>
            <a:xfrm>
              <a:off x="1440297" y="1388990"/>
              <a:ext cx="71823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EC136F5C-C9E9-FE29-FB29-DF41EDFA14DE}"/>
                </a:ext>
              </a:extLst>
            </p:cNvPr>
            <p:cNvCxnSpPr>
              <a:cxnSpLocks/>
              <a:stCxn id="8" idx="2"/>
              <a:endCxn id="6" idx="0"/>
            </p:cNvCxnSpPr>
            <p:nvPr/>
          </p:nvCxnSpPr>
          <p:spPr>
            <a:xfrm>
              <a:off x="2661447" y="3083854"/>
              <a:ext cx="0" cy="47472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Elbow Connector 24">
              <a:extLst>
                <a:ext uri="{FF2B5EF4-FFF2-40B4-BE49-F238E27FC236}">
                  <a16:creationId xmlns:a16="http://schemas.microsoft.com/office/drawing/2014/main" id="{EBCDC23A-850A-11F8-345A-CD67406C30D6}"/>
                </a:ext>
              </a:extLst>
            </p:cNvPr>
            <p:cNvCxnSpPr>
              <a:cxnSpLocks/>
              <a:stCxn id="6" idx="3"/>
              <a:endCxn id="19" idx="2"/>
            </p:cNvCxnSpPr>
            <p:nvPr/>
          </p:nvCxnSpPr>
          <p:spPr>
            <a:xfrm flipV="1">
              <a:off x="3164367" y="3172322"/>
              <a:ext cx="2225714" cy="606317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24B3A8F0-CCCE-2E7C-B7FD-D876E65E5E78}"/>
                </a:ext>
              </a:extLst>
            </p:cNvPr>
            <p:cNvCxnSpPr>
              <a:cxnSpLocks/>
            </p:cNvCxnSpPr>
            <p:nvPr/>
          </p:nvCxnSpPr>
          <p:spPr>
            <a:xfrm>
              <a:off x="4197862" y="1524411"/>
              <a:ext cx="0" cy="50253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BABF3647-BFED-08A5-55D4-F41D837B7E80}"/>
                </a:ext>
              </a:extLst>
            </p:cNvPr>
            <p:cNvCxnSpPr>
              <a:stCxn id="16" idx="0"/>
              <a:endCxn id="15" idx="2"/>
            </p:cNvCxnSpPr>
            <p:nvPr/>
          </p:nvCxnSpPr>
          <p:spPr>
            <a:xfrm flipV="1">
              <a:off x="5390081" y="1524411"/>
              <a:ext cx="0" cy="50253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F67F79DE-A841-EAE7-6679-45F52CA61A9E}"/>
                </a:ext>
              </a:extLst>
            </p:cNvPr>
            <p:cNvCxnSpPr>
              <a:stCxn id="17" idx="3"/>
              <a:endCxn id="16" idx="1"/>
            </p:cNvCxnSpPr>
            <p:nvPr/>
          </p:nvCxnSpPr>
          <p:spPr>
            <a:xfrm>
              <a:off x="4600198" y="2162365"/>
              <a:ext cx="38754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CE87DE2C-63EB-1264-6AF4-A0C9F164E522}"/>
                </a:ext>
              </a:extLst>
            </p:cNvPr>
            <p:cNvCxnSpPr>
              <a:stCxn id="16" idx="3"/>
              <a:endCxn id="14" idx="1"/>
            </p:cNvCxnSpPr>
            <p:nvPr/>
          </p:nvCxnSpPr>
          <p:spPr>
            <a:xfrm>
              <a:off x="5792417" y="2162365"/>
              <a:ext cx="40514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5FE6753F-E9F4-31AE-B3EB-6A70BD4D259C}"/>
                </a:ext>
              </a:extLst>
            </p:cNvPr>
            <p:cNvCxnSpPr>
              <a:cxnSpLocks/>
              <a:stCxn id="19" idx="0"/>
              <a:endCxn id="16" idx="2"/>
            </p:cNvCxnSpPr>
            <p:nvPr/>
          </p:nvCxnSpPr>
          <p:spPr>
            <a:xfrm flipV="1">
              <a:off x="5390081" y="2297786"/>
              <a:ext cx="0" cy="43562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978DECFF-B467-7A95-610B-86E8A9E252DB}"/>
                </a:ext>
              </a:extLst>
            </p:cNvPr>
            <p:cNvCxnSpPr>
              <a:stCxn id="7" idx="2"/>
              <a:endCxn id="8" idx="0"/>
            </p:cNvCxnSpPr>
            <p:nvPr/>
          </p:nvCxnSpPr>
          <p:spPr>
            <a:xfrm>
              <a:off x="2661447" y="2297786"/>
              <a:ext cx="0" cy="5152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FBDB1655-CE80-3C24-1593-E411D825086A}"/>
                </a:ext>
              </a:extLst>
            </p:cNvPr>
            <p:cNvCxnSpPr>
              <a:stCxn id="9" idx="2"/>
              <a:endCxn id="7" idx="0"/>
            </p:cNvCxnSpPr>
            <p:nvPr/>
          </p:nvCxnSpPr>
          <p:spPr>
            <a:xfrm>
              <a:off x="2661447" y="1524411"/>
              <a:ext cx="0" cy="50253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CCF4561-0E90-C505-1F9D-8D32A4878271}"/>
                </a:ext>
              </a:extLst>
            </p:cNvPr>
            <p:cNvSpPr txBox="1"/>
            <p:nvPr/>
          </p:nvSpPr>
          <p:spPr>
            <a:xfrm>
              <a:off x="2047254" y="4154392"/>
              <a:ext cx="1249360" cy="270843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 algn="ctr"/>
              <a:r>
                <a:rPr lang="en-US" sz="1100" dirty="0"/>
                <a:t>Asari workflow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D9943E12-87E2-3B1B-D2CE-5789A3593D91}"/>
              </a:ext>
            </a:extLst>
          </p:cNvPr>
          <p:cNvSpPr txBox="1"/>
          <p:nvPr/>
        </p:nvSpPr>
        <p:spPr>
          <a:xfrm>
            <a:off x="2152044" y="214721"/>
            <a:ext cx="73766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err="1"/>
              <a:t>MetDataModel</a:t>
            </a:r>
            <a:r>
              <a:rPr lang="en-US" sz="2000" dirty="0"/>
              <a:t>: Basic data structure in Computational Metabolomics</a:t>
            </a:r>
          </a:p>
        </p:txBody>
      </p:sp>
    </p:spTree>
    <p:extLst>
      <p:ext uri="{BB962C8B-B14F-4D97-AF65-F5344CB8AC3E}">
        <p14:creationId xmlns:p14="http://schemas.microsoft.com/office/powerpoint/2010/main" val="1955761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Oval 42"/>
          <p:cNvSpPr/>
          <p:nvPr/>
        </p:nvSpPr>
        <p:spPr>
          <a:xfrm>
            <a:off x="6259259" y="3099618"/>
            <a:ext cx="1730188" cy="646331"/>
          </a:xfrm>
          <a:prstGeom prst="ellipse">
            <a:avLst/>
          </a:prstGeom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Compound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018515" y="3099618"/>
            <a:ext cx="845103" cy="646331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/>
              <a:t>Elution</a:t>
            </a:r>
            <a:br>
              <a:rPr lang="en-US"/>
            </a:br>
            <a:r>
              <a:rPr lang="en-US"/>
              <a:t>Peak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250185" y="3238117"/>
            <a:ext cx="902555" cy="369332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Feature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3162235" y="3422783"/>
            <a:ext cx="365760" cy="0"/>
          </a:xfrm>
          <a:prstGeom prst="line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1884425" y="3422783"/>
            <a:ext cx="365760" cy="0"/>
          </a:xfrm>
          <a:prstGeom prst="line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218984" y="2932036"/>
            <a:ext cx="116410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solidFill>
                  <a:srgbClr val="C00000"/>
                </a:solidFill>
              </a:rPr>
              <a:t>Confidence level </a:t>
            </a:r>
          </a:p>
          <a:p>
            <a:pPr algn="ctr"/>
            <a:r>
              <a:rPr lang="en-US" sz="1100" dirty="0">
                <a:solidFill>
                  <a:srgbClr val="C00000"/>
                </a:solidFill>
              </a:rPr>
              <a:t>or Probability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152044" y="214721"/>
            <a:ext cx="15381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Version 202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783568" y="2480373"/>
            <a:ext cx="1128129" cy="64633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/>
              <a:t>Metabolic</a:t>
            </a:r>
            <a:br>
              <a:rPr lang="en-US"/>
            </a:br>
            <a:r>
              <a:rPr lang="en-US"/>
              <a:t>Network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9783568" y="3666403"/>
            <a:ext cx="977512" cy="3693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Pathway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349963" y="3238117"/>
            <a:ext cx="1003095" cy="3693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/>
              <a:t>Reaction</a:t>
            </a:r>
            <a:endParaRPr lang="en-US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7983860" y="3422783"/>
            <a:ext cx="3657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9349103" y="2978583"/>
            <a:ext cx="434465" cy="2595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>
            <a:endCxn id="11" idx="1"/>
          </p:cNvCxnSpPr>
          <p:nvPr/>
        </p:nvCxnSpPr>
        <p:spPr>
          <a:xfrm>
            <a:off x="9349103" y="3599271"/>
            <a:ext cx="434465" cy="25179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8395424" y="2591590"/>
            <a:ext cx="912173" cy="3693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Enzyme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8509910" y="1944946"/>
            <a:ext cx="683200" cy="3693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Gene</a:t>
            </a:r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8851510" y="2330358"/>
            <a:ext cx="0" cy="246888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8851510" y="2979361"/>
            <a:ext cx="0" cy="246888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202058" y="2472693"/>
            <a:ext cx="478016" cy="369332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/>
              <a:t>EIC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926340" y="4079515"/>
            <a:ext cx="8885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MS</a:t>
            </a:r>
            <a:r>
              <a:rPr lang="en-US" baseline="30000" dirty="0" err="1"/>
              <a:t>n</a:t>
            </a:r>
            <a:endParaRPr lang="en-US" baseline="30000" dirty="0"/>
          </a:p>
          <a:p>
            <a:pPr algn="ctr"/>
            <a:r>
              <a:rPr lang="en-US" dirty="0"/>
              <a:t>Spectra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788476" y="1969235"/>
            <a:ext cx="1239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notation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996778" y="1559408"/>
            <a:ext cx="888577" cy="646331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LC-MS</a:t>
            </a:r>
            <a:endParaRPr lang="en-US" baseline="30000" dirty="0"/>
          </a:p>
          <a:p>
            <a:pPr algn="ctr"/>
            <a:r>
              <a:rPr lang="en-US" dirty="0"/>
              <a:t>Spectra</a:t>
            </a:r>
          </a:p>
        </p:txBody>
      </p:sp>
      <p:sp>
        <p:nvSpPr>
          <p:cNvPr id="16" name="Oval 15"/>
          <p:cNvSpPr/>
          <p:nvPr/>
        </p:nvSpPr>
        <p:spPr>
          <a:xfrm>
            <a:off x="3547659" y="2930201"/>
            <a:ext cx="1721076" cy="985165"/>
          </a:xfrm>
          <a:prstGeom prst="ellipse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Empirical</a:t>
            </a:r>
            <a:br>
              <a:rPr lang="en-US" dirty="0"/>
            </a:br>
            <a:r>
              <a:rPr lang="en-US" dirty="0"/>
              <a:t>Compound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051258" y="2103212"/>
            <a:ext cx="12725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chemeClr val="accent6">
                    <a:lumMod val="75000"/>
                  </a:schemeClr>
                </a:solidFill>
              </a:rPr>
              <a:t>Other</a:t>
            </a:r>
          </a:p>
          <a:p>
            <a:pPr algn="ctr"/>
            <a:r>
              <a:rPr lang="en-US" dirty="0">
                <a:solidFill>
                  <a:schemeClr val="accent6">
                    <a:lumMod val="75000"/>
                  </a:schemeClr>
                </a:solidFill>
              </a:rPr>
              <a:t>approaches</a:t>
            </a:r>
          </a:p>
        </p:txBody>
      </p:sp>
      <p:cxnSp>
        <p:nvCxnSpPr>
          <p:cNvPr id="51" name="Straight Connector 50"/>
          <p:cNvCxnSpPr/>
          <p:nvPr/>
        </p:nvCxnSpPr>
        <p:spPr>
          <a:xfrm>
            <a:off x="2687554" y="2734731"/>
            <a:ext cx="0" cy="487704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4408197" y="2396898"/>
            <a:ext cx="0" cy="487704"/>
          </a:xfrm>
          <a:prstGeom prst="line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1439415" y="2208544"/>
            <a:ext cx="3303" cy="250734"/>
          </a:xfrm>
          <a:prstGeom prst="line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1439415" y="2837960"/>
            <a:ext cx="3303" cy="250734"/>
          </a:xfrm>
          <a:prstGeom prst="line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V="1">
            <a:off x="3696930" y="3967847"/>
            <a:ext cx="393290" cy="347331"/>
          </a:xfrm>
          <a:prstGeom prst="line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290021" y="3422783"/>
            <a:ext cx="969264" cy="0"/>
          </a:xfrm>
          <a:prstGeom prst="line">
            <a:avLst/>
          </a:prstGeom>
          <a:ln w="63500">
            <a:solidFill>
              <a:srgbClr val="C00000">
                <a:alpha val="58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934828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226916" y="1884218"/>
            <a:ext cx="4324139" cy="60036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Experiment</a:t>
            </a:r>
          </a:p>
        </p:txBody>
      </p:sp>
      <p:sp>
        <p:nvSpPr>
          <p:cNvPr id="5" name="Rectangle 4"/>
          <p:cNvSpPr/>
          <p:nvPr/>
        </p:nvSpPr>
        <p:spPr>
          <a:xfrm>
            <a:off x="5962073" y="1884218"/>
            <a:ext cx="4339456" cy="60036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Metabolic Mode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957522" y="3174037"/>
            <a:ext cx="628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Peak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975804" y="3174037"/>
            <a:ext cx="902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atur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288769" y="3174037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empCpd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055924" y="3170928"/>
            <a:ext cx="13486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Compound</a:t>
            </a:r>
            <a:br>
              <a:rPr lang="en-US" dirty="0"/>
            </a:br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(metabolite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069071" y="2660577"/>
            <a:ext cx="994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Network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9069071" y="3380468"/>
            <a:ext cx="9775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thway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742647" y="3174037"/>
            <a:ext cx="1003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Reaction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226916" y="2559816"/>
            <a:ext cx="4324139" cy="1977459"/>
          </a:xfrm>
          <a:prstGeom prst="rect">
            <a:avLst/>
          </a:prstGeom>
          <a:noFill/>
          <a:ln>
            <a:solidFill>
              <a:schemeClr val="accent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5977390" y="2559816"/>
            <a:ext cx="4324139" cy="1977459"/>
          </a:xfrm>
          <a:prstGeom prst="rect">
            <a:avLst/>
          </a:prstGeom>
          <a:noFill/>
          <a:ln>
            <a:solidFill>
              <a:schemeClr val="accent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Connector 17"/>
          <p:cNvCxnSpPr/>
          <p:nvPr/>
        </p:nvCxnSpPr>
        <p:spPr>
          <a:xfrm>
            <a:off x="3869121" y="3358703"/>
            <a:ext cx="4263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7311771" y="3360103"/>
            <a:ext cx="4263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8740920" y="2944856"/>
            <a:ext cx="326310" cy="2221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337887" y="3358703"/>
            <a:ext cx="718037" cy="0"/>
          </a:xfrm>
          <a:prstGeom prst="line">
            <a:avLst/>
          </a:prstGeom>
          <a:ln w="349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2577177" y="3358703"/>
            <a:ext cx="4263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8745742" y="3425205"/>
            <a:ext cx="343207" cy="13777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536133" y="305092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C00000"/>
                </a:solidFill>
              </a:rPr>
              <a:t>N:N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602963" y="5129983"/>
            <a:ext cx="440745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pectrum, Peak : sample specific</a:t>
            </a:r>
          </a:p>
          <a:p>
            <a:r>
              <a:rPr lang="en-US" sz="1400" dirty="0" err="1"/>
              <a:t>Featrure</a:t>
            </a:r>
            <a:r>
              <a:rPr lang="en-US" sz="1400" dirty="0"/>
              <a:t>, </a:t>
            </a:r>
            <a:r>
              <a:rPr lang="en-US" sz="1400" dirty="0" err="1"/>
              <a:t>empCpd</a:t>
            </a:r>
            <a:r>
              <a:rPr lang="en-US" sz="1400" dirty="0"/>
              <a:t> : experiment specific</a:t>
            </a:r>
          </a:p>
          <a:p>
            <a:r>
              <a:rPr lang="en-US" sz="1400" dirty="0" err="1"/>
              <a:t>empCpd</a:t>
            </a:r>
            <a:r>
              <a:rPr lang="en-US" sz="1400" dirty="0"/>
              <a:t> = Empirical Compound</a:t>
            </a:r>
          </a:p>
          <a:p>
            <a:r>
              <a:rPr lang="en-US" sz="1400" dirty="0"/>
              <a:t>N:N = many to many mapping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255565" y="3765162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pectrum</a:t>
            </a: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1885094" y="3562983"/>
            <a:ext cx="257742" cy="26195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7742647" y="3804793"/>
            <a:ext cx="912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Enzyme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754523" y="4106251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Gene</a:t>
            </a:r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7437723" y="4086446"/>
            <a:ext cx="323396" cy="162913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8198733" y="3561430"/>
            <a:ext cx="0" cy="263506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1D21768B-76EE-05F9-CFE5-3903854631C3}"/>
              </a:ext>
            </a:extLst>
          </p:cNvPr>
          <p:cNvSpPr txBox="1"/>
          <p:nvPr/>
        </p:nvSpPr>
        <p:spPr>
          <a:xfrm>
            <a:off x="2152044" y="214721"/>
            <a:ext cx="15381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Version 2020</a:t>
            </a:r>
          </a:p>
        </p:txBody>
      </p:sp>
    </p:spTree>
    <p:extLst>
      <p:ext uri="{BB962C8B-B14F-4D97-AF65-F5344CB8AC3E}">
        <p14:creationId xmlns:p14="http://schemas.microsoft.com/office/powerpoint/2010/main" val="1580959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144</Words>
  <Application>Microsoft Macintosh PowerPoint</Application>
  <PresentationFormat>Widescreen</PresentationFormat>
  <Paragraphs>6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zhao Li</dc:creator>
  <cp:lastModifiedBy>Shuzhao Li</cp:lastModifiedBy>
  <cp:revision>16</cp:revision>
  <dcterms:created xsi:type="dcterms:W3CDTF">2020-10-19T19:21:45Z</dcterms:created>
  <dcterms:modified xsi:type="dcterms:W3CDTF">2024-01-16T18:58:42Z</dcterms:modified>
</cp:coreProperties>
</file>